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2" d="100"/>
          <a:sy n="102" d="100"/>
        </p:scale>
        <p:origin x="83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iu, Bindong" userId="f2dc3555-f359-4306-8ea4-b1ecda13ff1e" providerId="ADAL" clId="{6F5FF259-23E3-4D24-AF3F-81023F98F5D5}"/>
    <pc:docChg chg="modSld">
      <pc:chgData name="Liu, Bindong" userId="f2dc3555-f359-4306-8ea4-b1ecda13ff1e" providerId="ADAL" clId="{6F5FF259-23E3-4D24-AF3F-81023F98F5D5}" dt="2024-05-04T04:10:21.932" v="13" actId="20577"/>
      <pc:docMkLst>
        <pc:docMk/>
      </pc:docMkLst>
      <pc:sldChg chg="modSp mod">
        <pc:chgData name="Liu, Bindong" userId="f2dc3555-f359-4306-8ea4-b1ecda13ff1e" providerId="ADAL" clId="{6F5FF259-23E3-4D24-AF3F-81023F98F5D5}" dt="2024-05-04T04:10:21.932" v="13" actId="20577"/>
        <pc:sldMkLst>
          <pc:docMk/>
          <pc:sldMk cId="1374232794" sldId="256"/>
        </pc:sldMkLst>
        <pc:spChg chg="mod">
          <ac:chgData name="Liu, Bindong" userId="f2dc3555-f359-4306-8ea4-b1ecda13ff1e" providerId="ADAL" clId="{6F5FF259-23E3-4D24-AF3F-81023F98F5D5}" dt="2024-05-04T04:09:50.151" v="3" actId="6549"/>
          <ac:spMkLst>
            <pc:docMk/>
            <pc:sldMk cId="1374232794" sldId="256"/>
            <ac:spMk id="10" creationId="{6B906AAF-0DCA-9A4A-F18E-89E67BD6CA69}"/>
          </ac:spMkLst>
        </pc:spChg>
        <pc:spChg chg="mod">
          <ac:chgData name="Liu, Bindong" userId="f2dc3555-f359-4306-8ea4-b1ecda13ff1e" providerId="ADAL" clId="{6F5FF259-23E3-4D24-AF3F-81023F98F5D5}" dt="2024-05-04T04:10:21.932" v="13" actId="20577"/>
          <ac:spMkLst>
            <pc:docMk/>
            <pc:sldMk cId="1374232794" sldId="256"/>
            <ac:spMk id="13" creationId="{60DD6AD7-9BB8-A066-EFB9-892457E4ED11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CF3600-BC55-63AF-43FB-0428818C3F5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B72D9F2-7E3C-1C71-94C1-ECE347B74C1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BF4BAB5-54FB-CF09-3B5C-81DD2710EE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0550B3-5A32-4D9C-8D45-6F5E0C39D4ED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475251-107C-625F-6FCF-F2AC51A0D5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136872-F973-B6AD-2856-18A66FAC0C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3BE727-1582-45B9-920A-DAD3CA6624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38260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56EC2A-1D3E-55FB-93D8-F7098095C6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4F3E48B-70FD-C748-F37D-FC981B91225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700FB7-81A3-B7FA-F4F2-103236CE4F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0550B3-5A32-4D9C-8D45-6F5E0C39D4ED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0B4951-7AC1-869B-947E-1AC38AA9CC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70B215F-C1D2-664A-506C-CF8CD137A8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3BE727-1582-45B9-920A-DAD3CA6624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26239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7B46CB2-9A00-EAD3-66E1-A0660216911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C3D02BB-D696-FEF6-10AE-8738CE534A9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B2C87A-79ED-3B09-346C-373FB35597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0550B3-5A32-4D9C-8D45-6F5E0C39D4ED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F40644-9151-5D46-F93E-26A2C018CE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AE94AD-E791-2BCC-2268-D9C83BA29E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3BE727-1582-45B9-920A-DAD3CA6624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82574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6A2444-EA1F-16FD-4984-36682401CE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43CCAE9-4778-AC03-1C2C-4C5CAF4DF5C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E5D9CA-501D-3103-C40E-CCB7D7BF45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0550B3-5A32-4D9C-8D45-6F5E0C39D4ED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993866-CF55-C577-C3A0-92A13DC405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DBB858-36F8-1F1F-0669-626723D868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3BE727-1582-45B9-920A-DAD3CA6624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03396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24D030-FDD5-75CF-E093-732D23B070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61478A6-68A3-C31E-C5AE-711F6D90C86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E33C6C6-6E4C-0B04-082F-5090CEB050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0550B3-5A32-4D9C-8D45-6F5E0C39D4ED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952E36-54E2-9611-9F47-EFE612665C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94340A-5EA4-B74D-E09D-E592F027BA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3BE727-1582-45B9-920A-DAD3CA6624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40109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236E74-C423-4929-09FA-3E64A52226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A593C12-887E-D675-D5DF-AF231C20F6B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0CD910D-17B9-D56D-2044-454DE57CCBE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D19AF26-2C3F-90BA-20BB-1F384CEC26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0550B3-5A32-4D9C-8D45-6F5E0C39D4ED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19A1BD2-9B00-40EF-2953-CFE56A0C48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8D5E354-6379-9661-35FD-6DA9F928F7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3BE727-1582-45B9-920A-DAD3CA6624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0705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5E52D6-636C-C230-43BC-45A80D998F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A90F78E-AB01-DF17-57F3-D5531EED82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3F8069B-8081-B6CB-C2F3-AEA29C1EA33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0BB5D08-B902-D10C-622E-1E51B4EA795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7517F19-E87A-0F1A-AA00-2CF04FEDCED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39A526F-5B89-B238-C4A6-EF16AFD9FC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0550B3-5A32-4D9C-8D45-6F5E0C39D4ED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1DF56F4-5FED-C054-0AEE-108BBD8320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431BFA7-02DF-10E7-1F02-C53AAE7D73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3BE727-1582-45B9-920A-DAD3CA6624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73334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DB03D1-2FB2-43C6-F8C2-539572AA41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E8155A3-B775-FB97-8D83-511A8C86C8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0550B3-5A32-4D9C-8D45-6F5E0C39D4ED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4C1BD43-C213-0040-B4B2-361B52AE26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741F7DA-6653-7FB7-50D3-05924CC437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3BE727-1582-45B9-920A-DAD3CA6624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03495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A689B7F-D4BC-20C8-1A6D-EB5D596B8F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0550B3-5A32-4D9C-8D45-6F5E0C39D4ED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5DF8027-7922-3125-AB83-1513173644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631F783-48D9-EC9B-6442-331F2CA941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3BE727-1582-45B9-920A-DAD3CA6624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35090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D3332D-0C99-3DAE-9868-A4105161B3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E4EFF60-8BE6-3EA5-C38E-F907A1BF4E3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AEF8E3F-1C51-DAB3-9CF5-0B16C3A3316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C9D4EEE-DE1E-DDE0-7167-C914156E84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0550B3-5A32-4D9C-8D45-6F5E0C39D4ED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A85A797-F29A-ECF7-B085-CEB440F54E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2D66FD2-2F67-54E7-9A4C-4B8A9715BD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3BE727-1582-45B9-920A-DAD3CA6624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24973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C71CF1-F690-2089-E863-0090D9D5EE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2CFA67C-FA5F-B25D-FBC4-F1AA32F8B09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DC2B970-F239-56DA-8DDB-67CC98FCF55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EDBB1D0-E25E-A64C-2A28-FFFFC42AC7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0550B3-5A32-4D9C-8D45-6F5E0C39D4ED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9B00436-0AE4-A664-02A9-31EDDC80AF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3E36897-16EC-C527-0C54-7DF84049BD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3BE727-1582-45B9-920A-DAD3CA6624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96876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B6D2685-FD11-EDB9-2474-F9A2CA2023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3308E84-F183-58D9-058E-C72990473D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F431F4-9CFC-219A-6F9B-25B1B1496EF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20550B3-5A32-4D9C-8D45-6F5E0C39D4ED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25EDB4-83EF-7CAC-8A8B-FB08DD466A2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CB6DE5-357F-1E43-BC8D-0C835381F04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E3BE727-1582-45B9-920A-DAD3CA6624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31760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44228E08-E4ED-267F-E372-05F45C7E453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6328" y="1671001"/>
            <a:ext cx="10617272" cy="1757999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6B906AAF-0DCA-9A4A-F18E-89E67BD6CA69}"/>
              </a:ext>
            </a:extLst>
          </p:cNvPr>
          <p:cNvSpPr txBox="1"/>
          <p:nvPr/>
        </p:nvSpPr>
        <p:spPr>
          <a:xfrm>
            <a:off x="516328" y="755009"/>
            <a:ext cx="103613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Palatino Linotype" panose="02040502050505030304" pitchFamily="18" charset="0"/>
              </a:rPr>
              <a:t>Fig. S1                         The HIV-1 IIIB </a:t>
            </a:r>
            <a:r>
              <a:rPr lang="en-US" dirty="0" err="1">
                <a:latin typeface="Palatino Linotype" panose="02040502050505030304" pitchFamily="18" charset="0"/>
              </a:rPr>
              <a:t>nef</a:t>
            </a:r>
            <a:r>
              <a:rPr lang="en-US" dirty="0">
                <a:latin typeface="Palatino Linotype" panose="02040502050505030304" pitchFamily="18" charset="0"/>
              </a:rPr>
              <a:t>-LTR region used for G-to-A hypermutation analysis              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0DD6AD7-9BB8-A066-EFB9-892457E4ED11}"/>
              </a:ext>
            </a:extLst>
          </p:cNvPr>
          <p:cNvSpPr txBox="1"/>
          <p:nvPr/>
        </p:nvSpPr>
        <p:spPr>
          <a:xfrm>
            <a:off x="922648" y="4068390"/>
            <a:ext cx="980463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Palatino Linotype" panose="02040502050505030304" pitchFamily="18" charset="0"/>
              </a:rPr>
              <a:t>Figure S1</a:t>
            </a:r>
            <a:r>
              <a:rPr lang="en-US" sz="1200" dirty="0">
                <a:latin typeface="Palatino Linotype" panose="02040502050505030304" pitchFamily="18" charset="0"/>
              </a:rPr>
              <a:t>. A 199 bp DNA fragment within the </a:t>
            </a:r>
            <a:r>
              <a:rPr lang="en-US" sz="1200" dirty="0" err="1">
                <a:latin typeface="Palatino Linotype" panose="02040502050505030304" pitchFamily="18" charset="0"/>
              </a:rPr>
              <a:t>nef</a:t>
            </a:r>
            <a:r>
              <a:rPr lang="en-US" sz="1200" dirty="0">
                <a:latin typeface="Palatino Linotype" panose="02040502050505030304" pitchFamily="18" charset="0"/>
              </a:rPr>
              <a:t>-LTR region of the HIV-1 IIIB genome was amplified by PCR and submitted for NGS-based G-to-A hypermutation analysis. After trimming off the primer binding regions, the guanines highlighted in red are potential substrates for A3G cytidine deaminase, which were used in our figures for G-to-A hypermutation analysis.  </a:t>
            </a:r>
          </a:p>
        </p:txBody>
      </p:sp>
    </p:spTree>
    <p:extLst>
      <p:ext uri="{BB962C8B-B14F-4D97-AF65-F5344CB8AC3E}">
        <p14:creationId xmlns:p14="http://schemas.microsoft.com/office/powerpoint/2010/main" val="13742327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4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Palatino Linotype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u, Bindong</dc:creator>
  <cp:lastModifiedBy>B Liu</cp:lastModifiedBy>
  <cp:revision>1</cp:revision>
  <dcterms:created xsi:type="dcterms:W3CDTF">2024-04-16T21:12:29Z</dcterms:created>
  <dcterms:modified xsi:type="dcterms:W3CDTF">2024-05-04T04:10:28Z</dcterms:modified>
</cp:coreProperties>
</file>